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8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8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74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911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569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208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313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074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718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69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546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726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93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554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15BE55-CAA2-4441-AA76-5FA55FBC372E}" type="datetimeFigureOut">
              <a:rPr lang="en-US" smtClean="0"/>
              <a:t>5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772D71-699F-439D-8003-CC3AF271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946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8EC99D9-6D78-4DE5-9BCE-8FE0C3A71FDC}"/>
              </a:ext>
            </a:extLst>
          </p:cNvPr>
          <p:cNvSpPr txBox="1"/>
          <p:nvPr/>
        </p:nvSpPr>
        <p:spPr>
          <a:xfrm>
            <a:off x="7724094" y="6431095"/>
            <a:ext cx="1255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B31394-6459-4A38-8F67-6E48F81019E8}"/>
              </a:ext>
            </a:extLst>
          </p:cNvPr>
          <p:cNvSpPr txBox="1"/>
          <p:nvPr/>
        </p:nvSpPr>
        <p:spPr>
          <a:xfrm>
            <a:off x="1449656" y="1433625"/>
            <a:ext cx="25991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ell fusion in 293T co-cultu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0BE73B-1A75-4C8F-8FB1-8269CD10ABDB}"/>
              </a:ext>
            </a:extLst>
          </p:cNvPr>
          <p:cNvSpPr txBox="1"/>
          <p:nvPr/>
        </p:nvSpPr>
        <p:spPr>
          <a:xfrm>
            <a:off x="4991871" y="1433625"/>
            <a:ext cx="29502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ell viability in co-culture of 293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28E432-81AD-42A3-95FC-DADBB2DAE089}"/>
              </a:ext>
            </a:extLst>
          </p:cNvPr>
          <p:cNvSpPr txBox="1"/>
          <p:nvPr/>
        </p:nvSpPr>
        <p:spPr>
          <a:xfrm>
            <a:off x="1131609" y="1416847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8B6D988-4C09-4665-83C0-91D2121F0F0E}"/>
              </a:ext>
            </a:extLst>
          </p:cNvPr>
          <p:cNvSpPr txBox="1"/>
          <p:nvPr/>
        </p:nvSpPr>
        <p:spPr>
          <a:xfrm>
            <a:off x="4691840" y="1416847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055F9D6-7E6A-46ED-88BE-42F3242EC5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0224" y="1643826"/>
            <a:ext cx="2950231" cy="378863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5749A93-EC8A-4BE2-8922-73C9B0C9D0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441" y="1643825"/>
            <a:ext cx="3111528" cy="3925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3578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4F0AFB7-E41C-455A-878F-4728BDE428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2111" y="354587"/>
            <a:ext cx="2845983" cy="26546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F3872D9-73B9-48E5-BB60-C898D7BFEF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217" b="27957"/>
          <a:stretch/>
        </p:blipFill>
        <p:spPr>
          <a:xfrm>
            <a:off x="4377617" y="1021786"/>
            <a:ext cx="1492931" cy="5746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2B83160-E136-4EAA-86C7-7FCC4A5DDA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3601" y="326548"/>
            <a:ext cx="2971151" cy="278150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937D96D-F9D2-40A7-B113-9AFB8B52CC4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25" r="15623"/>
          <a:stretch/>
        </p:blipFill>
        <p:spPr>
          <a:xfrm>
            <a:off x="7510688" y="1104571"/>
            <a:ext cx="1500379" cy="57464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3697D7B-AD0E-49C6-B8D7-EE71931B90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0977" y="3615544"/>
            <a:ext cx="3049492" cy="286773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3F87B61-A264-40A9-BC5C-2D6FE9CFDC8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4187"/>
          <a:stretch/>
        </p:blipFill>
        <p:spPr>
          <a:xfrm>
            <a:off x="2382660" y="4527867"/>
            <a:ext cx="1596039" cy="62460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6F13E23-8F84-4C57-BE02-B6B7ED05ACE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52402" y="3640014"/>
            <a:ext cx="2930682" cy="285253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15CD063-BDB4-4ECA-A398-934F44B10F2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17743" y="4442856"/>
            <a:ext cx="1874225" cy="604306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842D5BEA-5326-4145-B4BC-7A2776C79336}"/>
              </a:ext>
            </a:extLst>
          </p:cNvPr>
          <p:cNvSpPr/>
          <p:nvPr/>
        </p:nvSpPr>
        <p:spPr>
          <a:xfrm>
            <a:off x="4008628" y="60957"/>
            <a:ext cx="18619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3T-S-∆19-EGFP 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A82AD52-A67B-4708-9B7F-E64AE9C3BF4A}"/>
              </a:ext>
            </a:extLst>
          </p:cNvPr>
          <p:cNvSpPr/>
          <p:nvPr/>
        </p:nvSpPr>
        <p:spPr>
          <a:xfrm>
            <a:off x="920977" y="60957"/>
            <a:ext cx="17625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3T-S-WT-EGFP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D885236-5F48-4BED-8726-6CFE34F54A28}"/>
              </a:ext>
            </a:extLst>
          </p:cNvPr>
          <p:cNvSpPr/>
          <p:nvPr/>
        </p:nvSpPr>
        <p:spPr>
          <a:xfrm>
            <a:off x="6703560" y="0"/>
            <a:ext cx="2205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3T-hACE2-mCherry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397E0E3-C26F-49E7-8BE1-F2649D599493}"/>
              </a:ext>
            </a:extLst>
          </p:cNvPr>
          <p:cNvSpPr/>
          <p:nvPr/>
        </p:nvSpPr>
        <p:spPr>
          <a:xfrm>
            <a:off x="1104849" y="3235976"/>
            <a:ext cx="220554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3T-S-WT-EGFP + </a:t>
            </a:r>
          </a:p>
          <a:p>
            <a:r>
              <a:rPr lang="en-US" dirty="0"/>
              <a:t>293T-hACE2-mCherry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996E5EC-AF1C-4340-B908-3A2DA052BDB8}"/>
              </a:ext>
            </a:extLst>
          </p:cNvPr>
          <p:cNvSpPr/>
          <p:nvPr/>
        </p:nvSpPr>
        <p:spPr>
          <a:xfrm>
            <a:off x="4439904" y="3289529"/>
            <a:ext cx="225843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3T-S-∆19-EGFP +</a:t>
            </a:r>
          </a:p>
          <a:p>
            <a:r>
              <a:rPr lang="en-US" dirty="0"/>
              <a:t>293T-hACE2-mCherry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6B00F48-73F7-4169-B220-9E62D8369F02}"/>
              </a:ext>
            </a:extLst>
          </p:cNvPr>
          <p:cNvSpPr/>
          <p:nvPr/>
        </p:nvSpPr>
        <p:spPr>
          <a:xfrm>
            <a:off x="7777537" y="6376336"/>
            <a:ext cx="123392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2. 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9B653C5-A0D1-4E82-AA34-4F330B947D7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2933" y="366993"/>
            <a:ext cx="2845983" cy="265874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934689C-60C3-4336-A193-A28DE843BA4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15505"/>
          <a:stretch/>
        </p:blipFill>
        <p:spPr>
          <a:xfrm>
            <a:off x="1436323" y="1125415"/>
            <a:ext cx="1542593" cy="591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005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grass, outdoor, reef, garden&#10;&#10;Description automatically generated">
            <a:extLst>
              <a:ext uri="{FF2B5EF4-FFF2-40B4-BE49-F238E27FC236}">
                <a16:creationId xmlns:a16="http://schemas.microsoft.com/office/drawing/2014/main" id="{73AD742F-5B5A-4377-8F10-D686281FA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8177" y="3521956"/>
            <a:ext cx="2471196" cy="2471196"/>
          </a:xfrm>
          <a:prstGeom prst="rect">
            <a:avLst/>
          </a:prstGeom>
        </p:spPr>
      </p:pic>
      <p:pic>
        <p:nvPicPr>
          <p:cNvPr id="9" name="Picture 8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3C5FC2EC-8A35-469B-96A4-92DDC73E36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845611" y="3521956"/>
            <a:ext cx="2471196" cy="2471196"/>
          </a:xfrm>
          <a:prstGeom prst="rect">
            <a:avLst/>
          </a:prstGeom>
        </p:spPr>
      </p:pic>
      <p:pic>
        <p:nvPicPr>
          <p:cNvPr id="11" name="Picture 10" descr="A picture containing nature&#10;&#10;Description automatically generated">
            <a:extLst>
              <a:ext uri="{FF2B5EF4-FFF2-40B4-BE49-F238E27FC236}">
                <a16:creationId xmlns:a16="http://schemas.microsoft.com/office/drawing/2014/main" id="{8C9C67A9-D002-48E8-8EB1-327778DCC5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611" y="785642"/>
            <a:ext cx="2471198" cy="2471198"/>
          </a:xfrm>
          <a:prstGeom prst="rect">
            <a:avLst/>
          </a:prstGeom>
        </p:spPr>
      </p:pic>
      <p:pic>
        <p:nvPicPr>
          <p:cNvPr id="13" name="Picture 12" descr="A picture containing nature, old, crater&#10;&#10;Description automatically generated">
            <a:extLst>
              <a:ext uri="{FF2B5EF4-FFF2-40B4-BE49-F238E27FC236}">
                <a16:creationId xmlns:a16="http://schemas.microsoft.com/office/drawing/2014/main" id="{EA51B610-6336-4176-A432-8B6F14C4A59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8177" y="785641"/>
            <a:ext cx="2471197" cy="2471197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137E5A08-62F7-4DB6-93DF-64D5A3FE1E0B}"/>
              </a:ext>
            </a:extLst>
          </p:cNvPr>
          <p:cNvSpPr/>
          <p:nvPr/>
        </p:nvSpPr>
        <p:spPr>
          <a:xfrm>
            <a:off x="4377931" y="169942"/>
            <a:ext cx="268028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S-WT-GFP-</a:t>
            </a:r>
            <a:r>
              <a:rPr lang="en-US" dirty="0">
                <a:solidFill>
                  <a:srgbClr val="00B050"/>
                </a:solidFill>
              </a:rPr>
              <a:t>Sk-Hep1 </a:t>
            </a:r>
            <a:r>
              <a:rPr lang="en-US" dirty="0"/>
              <a:t>+ </a:t>
            </a:r>
          </a:p>
          <a:p>
            <a:pPr algn="ctr"/>
            <a:r>
              <a:rPr lang="en-US" dirty="0"/>
              <a:t>ACE2-mCherry-</a:t>
            </a:r>
            <a:r>
              <a:rPr lang="en-US" dirty="0">
                <a:solidFill>
                  <a:srgbClr val="FF0000"/>
                </a:solidFill>
              </a:rPr>
              <a:t>Sk-Hep1</a:t>
            </a:r>
            <a:r>
              <a:rPr lang="en-US" dirty="0"/>
              <a:t>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48057CE-4EFD-4C3C-960C-3210E97A3CDF}"/>
              </a:ext>
            </a:extLst>
          </p:cNvPr>
          <p:cNvSpPr/>
          <p:nvPr/>
        </p:nvSpPr>
        <p:spPr>
          <a:xfrm>
            <a:off x="2255685" y="416309"/>
            <a:ext cx="20217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-WT-GFP-</a:t>
            </a:r>
            <a:r>
              <a:rPr lang="en-US" dirty="0">
                <a:solidFill>
                  <a:srgbClr val="00B050"/>
                </a:solidFill>
              </a:rPr>
              <a:t>Sk-Hep1</a:t>
            </a:r>
            <a:r>
              <a:rPr lang="en-US" dirty="0"/>
              <a:t>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58C22BB-8727-49A5-96E4-67A5F2D8A293}"/>
              </a:ext>
            </a:extLst>
          </p:cNvPr>
          <p:cNvSpPr txBox="1"/>
          <p:nvPr/>
        </p:nvSpPr>
        <p:spPr>
          <a:xfrm rot="16200000">
            <a:off x="1345586" y="1842001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226521-741E-4204-ACD4-3CA7DE02D486}"/>
              </a:ext>
            </a:extLst>
          </p:cNvPr>
          <p:cNvSpPr txBox="1"/>
          <p:nvPr/>
        </p:nvSpPr>
        <p:spPr>
          <a:xfrm rot="16200000">
            <a:off x="1117885" y="4120007"/>
            <a:ext cx="905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FECBEB0-218F-4D98-84E0-CA2D0DF3860A}"/>
              </a:ext>
            </a:extLst>
          </p:cNvPr>
          <p:cNvSpPr/>
          <p:nvPr/>
        </p:nvSpPr>
        <p:spPr>
          <a:xfrm>
            <a:off x="7851776" y="6404118"/>
            <a:ext cx="11792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3. </a:t>
            </a:r>
          </a:p>
        </p:txBody>
      </p:sp>
    </p:spTree>
    <p:extLst>
      <p:ext uri="{BB962C8B-B14F-4D97-AF65-F5344CB8AC3E}">
        <p14:creationId xmlns:p14="http://schemas.microsoft.com/office/powerpoint/2010/main" val="38659944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5710E58-1EE8-4B3B-91D6-D9742D06C1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7736" y="1622864"/>
            <a:ext cx="3240722" cy="338575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67E8C2D-4136-4821-868E-D59F920C36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1622864"/>
            <a:ext cx="3240722" cy="338575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8EC99D9-6D78-4DE5-9BCE-8FE0C3A71FDC}"/>
              </a:ext>
            </a:extLst>
          </p:cNvPr>
          <p:cNvSpPr txBox="1"/>
          <p:nvPr/>
        </p:nvSpPr>
        <p:spPr>
          <a:xfrm>
            <a:off x="7812722" y="6297904"/>
            <a:ext cx="1206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864BF0B-5755-4AC8-BCB0-1550F4B8FBCC}"/>
              </a:ext>
            </a:extLst>
          </p:cNvPr>
          <p:cNvSpPr/>
          <p:nvPr/>
        </p:nvSpPr>
        <p:spPr>
          <a:xfrm>
            <a:off x="1331278" y="1110097"/>
            <a:ext cx="292813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S-WT-GFP-A549 + </a:t>
            </a:r>
          </a:p>
          <a:p>
            <a:pPr algn="ctr"/>
            <a:r>
              <a:rPr lang="en-US" dirty="0"/>
              <a:t>ACE2-mCherry-A549-0 </a:t>
            </a:r>
            <a:r>
              <a:rPr lang="en-US" dirty="0" err="1"/>
              <a:t>hr</a:t>
            </a:r>
            <a:r>
              <a:rPr lang="en-US" dirty="0"/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C31265B-2266-448A-889F-BFF19FE88222}"/>
              </a:ext>
            </a:extLst>
          </p:cNvPr>
          <p:cNvSpPr/>
          <p:nvPr/>
        </p:nvSpPr>
        <p:spPr>
          <a:xfrm>
            <a:off x="4884590" y="1110096"/>
            <a:ext cx="292813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S-WT-GFP-A549 + </a:t>
            </a:r>
          </a:p>
          <a:p>
            <a:pPr algn="ctr"/>
            <a:r>
              <a:rPr lang="en-US" dirty="0"/>
              <a:t>ACE2-mCherry-A549-24 </a:t>
            </a:r>
            <a:r>
              <a:rPr lang="en-US" dirty="0" err="1"/>
              <a:t>hr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78182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</TotalTime>
  <Words>54</Words>
  <Application>Microsoft Office PowerPoint</Application>
  <PresentationFormat>On-screen Show (4:3)</PresentationFormat>
  <Paragraphs>2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aditya Badeti</dc:creator>
  <cp:lastModifiedBy>Shuching Lung</cp:lastModifiedBy>
  <cp:revision>26</cp:revision>
  <dcterms:created xsi:type="dcterms:W3CDTF">2021-05-19T18:01:10Z</dcterms:created>
  <dcterms:modified xsi:type="dcterms:W3CDTF">2021-05-22T15:27:29Z</dcterms:modified>
</cp:coreProperties>
</file>